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264" r:id="rId2"/>
    <p:sldId id="267" r:id="rId3"/>
  </p:sldIdLst>
  <p:sldSz cx="6858000" cy="9906000" type="A4"/>
  <p:notesSz cx="6797675" cy="9926638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D5D5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浅色样式 3 - 强调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265" autoAdjust="0"/>
    <p:restoredTop sz="89111" autoAdjust="0"/>
  </p:normalViewPr>
  <p:slideViewPr>
    <p:cSldViewPr snapToGrid="0">
      <p:cViewPr>
        <p:scale>
          <a:sx n="75" d="100"/>
          <a:sy n="75" d="100"/>
        </p:scale>
        <p:origin x="1950" y="-9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4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19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4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190"/>
            </a:lvl1pPr>
          </a:lstStyle>
          <a:p>
            <a:fld id="{0F9B84EA-7D68-4D60-9CB1-D50884785D1C}" type="datetimeFigureOut">
              <a:rPr lang="zh-CN" altLang="en-US" smtClean="0"/>
              <a:t>2019/4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428281"/>
            <a:ext cx="2945659" cy="49803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9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50443" y="9428281"/>
            <a:ext cx="2945659" cy="49803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19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554014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8167BA-00AE-4330-A90C-0A71427533EC}" type="datetimeFigureOut">
              <a:rPr lang="zh-CN" altLang="en-US" smtClean="0"/>
              <a:t>2019/4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E3AC74-90A7-43DF-A71E-EA7C84960C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079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E3AC74-90A7-43DF-A71E-EA7C84960C7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49418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13746-883A-4F40-88EC-89A57D09C947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2019/4/2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53CAE-85EA-43C1-9E5F-E5C840641E4E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905" indent="-128905" algn="l" defTabSz="514350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60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32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4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76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78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95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9130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6305" indent="-128905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2403265"/>
              </p:ext>
            </p:extLst>
          </p:nvPr>
        </p:nvGraphicFramePr>
        <p:xfrm>
          <a:off x="388620" y="1320060"/>
          <a:ext cx="2926080" cy="616204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35305"/>
                <a:gridCol w="285750"/>
                <a:gridCol w="2105025"/>
              </a:tblGrid>
              <a:tr h="502005">
                <a:tc gridSpan="3">
                  <a:txBody>
                    <a:bodyPr/>
                    <a:lstStyle/>
                    <a:p>
                      <a:pPr algn="ctr" fontAlgn="ctr">
                        <a:lnSpc>
                          <a:spcPct val="150000"/>
                        </a:lnSpc>
                      </a:pPr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quences </a:t>
                      </a:r>
                      <a:r>
                        <a:rPr lang="en-US" sz="10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f</a:t>
                      </a:r>
                      <a:r>
                        <a:rPr lang="en-US" sz="1000" b="1" i="0" u="none" strike="noStrike" kern="1200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meta-related</a:t>
                      </a:r>
                      <a:r>
                        <a:rPr lang="en-US" sz="10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imers used </a:t>
                      </a:r>
                      <a:r>
                        <a:rPr lang="en-US" sz="10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or qRT-PCR</a:t>
                      </a:r>
                    </a:p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</a:tr>
              <a:tr h="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RX6</a:t>
                      </a:r>
                      <a:endParaRPr lang="en-US" sz="10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TGGCCTCACTACTCCT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TGGCCTCACTACTCCT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l-GR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CGTGCGTGACATTAAGG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GTGTTGGCGTACAGGTCT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PDH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GCTGTTGTCATACTTCTCATGG</a:t>
                      </a: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GAGCGAGATCCCTCCAAAAT</a:t>
                      </a:r>
                    </a:p>
                  </a:txBody>
                  <a:tcPr marL="9525" marR="9525" marT="9525" marB="0" anchor="b"/>
                </a:tc>
              </a:tr>
              <a:tr h="177165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00000"/>
                        </a:lnSpc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ACGCTTCACGAATTTGCGT</a:t>
                      </a:r>
                    </a:p>
                  </a:txBody>
                  <a:tcPr marL="9525" marR="9525" marT="9525" marB="0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TCGCTTCGGCAGCACA</a:t>
                      </a: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T primer</a:t>
                      </a:r>
                    </a:p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:AACGCTTCACGAATTTGCGT</a:t>
                      </a:r>
                    </a:p>
                  </a:txBody>
                  <a:tcPr marL="9525" marR="9525" marT="9525" marB="0" anchor="b"/>
                </a:tc>
              </a:tr>
              <a:tr h="177165">
                <a:tc rowSpan="2">
                  <a:txBody>
                    <a:bodyPr/>
                    <a:lstStyle/>
                    <a:p>
                      <a:pPr marL="0" marR="0" lvl="0" indent="0" algn="l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AS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GAGGTGTTCTATGAGCTGG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CTTGTGTGTTCGCAGGAA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rowSpan="2">
                  <a:txBody>
                    <a:bodyPr/>
                    <a:lstStyle/>
                    <a:p>
                      <a:pPr marL="0" marR="0" lvl="0" indent="0" algn="l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TIMP1</a:t>
                      </a:r>
                      <a:endParaRPr lang="en-US" altLang="zh-CN" sz="10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TCTGCAATTCCGACCTCGT</a:t>
                      </a:r>
                      <a:endParaRPr lang="en-US" alt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GCTGGTATAAGGTGGTCTG</a:t>
                      </a:r>
                      <a:endParaRPr lang="en-US" alt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rowSpan="2">
                  <a:txBody>
                    <a:bodyPr/>
                    <a:lstStyle/>
                    <a:p>
                      <a:pPr marL="0" marR="0" lvl="0" indent="0" algn="l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P2</a:t>
                      </a:r>
                      <a:endParaRPr lang="en-US" altLang="zh-CN" sz="10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GCGGTCAGTGAGAAGGAAG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GGGCCGTGTAGATAAACTCTAT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23825">
                <a:tc rowSpan="2">
                  <a:txBody>
                    <a:bodyPr/>
                    <a:lstStyle/>
                    <a:p>
                      <a:pPr marL="0" marR="0" lvl="0" indent="0" algn="l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+mn-ea"/>
                        </a:rPr>
                        <a:t>METAP2</a:t>
                      </a:r>
                      <a:endParaRPr lang="en-US" altLang="zh-CN" sz="10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AGGACAAGAATGCGAATACCC</a:t>
                      </a:r>
                      <a:endParaRPr lang="en-US" alt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  <a:buNone/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GGCTTGATCCAGCTCATTAC</a:t>
                      </a:r>
                      <a:endParaRPr lang="en-US" alt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MP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TGGGGAAAACCTTTCGACT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5621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CCAACGTATTCAAAAGCACAA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MP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ACTTTCTTGGATCGGGTCG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25095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GCACCACATCAGATGACTG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25095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MP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TACCGCTATGGTTACACTCG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GCAGGGACAGTTGCTTCT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63195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MP1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TGAGAGGCTCCGAGAAATG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ACCCCGCATCTTGGCTT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LT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CACGAGGTACATGCCAAC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47955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TGCTCAAAGTCTCTCACGAA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D4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GATTTGAATGTAACCTGCCG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GTCCGGGAGATACTGTAGC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7165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RC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GGACACTCAGGAGAAGAACG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CTGCTTAATAATCTTGCCCTT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0">
                <a:tc rowSpan="2">
                  <a:txBody>
                    <a:bodyPr/>
                    <a:lstStyle/>
                    <a:p>
                      <a:pPr marL="0" marR="0" lvl="0" indent="0" algn="l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KDM3A</a:t>
                      </a:r>
                    </a:p>
                  </a:txBody>
                  <a:tcPr marL="9525" marR="9525" marT="9525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GCTCACGCTCGGAGAA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>
                      <a:noFill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GGGAAACAGCTCGAATGGT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0781972"/>
              </p:ext>
            </p:extLst>
          </p:nvPr>
        </p:nvGraphicFramePr>
        <p:xfrm>
          <a:off x="400050" y="7523629"/>
          <a:ext cx="2914650" cy="135228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18154"/>
                <a:gridCol w="285756"/>
                <a:gridCol w="2110740"/>
              </a:tblGrid>
              <a:tr h="131183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S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GGAGGACTCAACAAGAGATG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36898">
                <a:tc v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ATATCCGTTTCTCCCACTTC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89273">
                <a:tc rowSpan="2">
                  <a:txBody>
                    <a:bodyPr/>
                    <a:lstStyle/>
                    <a:p>
                      <a:pPr marL="0" marR="0" lvl="0" indent="0" algn="l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NNB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AGCGGCTGTTAGTCACTGG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25468">
                <a:tc vMerge="1"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en-US" altLang="zh-CN" sz="1100" b="1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AGTCATTGCATACTGTCCAT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84523">
                <a:tc rowSpan="2">
                  <a:txBody>
                    <a:bodyPr/>
                    <a:lstStyle/>
                    <a:p>
                      <a:pPr marL="0" marR="0" lvl="0" indent="0" algn="l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FB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ACAGCACGGTATGCAAGCC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82880">
                <a:tc vMerge="1"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en-US" altLang="zh-CN" sz="1100" b="1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AACCGATCTAGCTCACAGAG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5260">
                <a:tc rowSpan="2">
                  <a:txBody>
                    <a:bodyPr/>
                    <a:lstStyle/>
                    <a:p>
                      <a:pPr marL="0" marR="0" lvl="0" indent="0" algn="l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AP2K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CAGGGTAAACGCAAAGC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 vMerge="1"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endParaRPr lang="en-US" altLang="zh-CN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0" i="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CCTGTAGGATTGGGATTCAG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5812149"/>
              </p:ext>
            </p:extLst>
          </p:nvPr>
        </p:nvGraphicFramePr>
        <p:xfrm>
          <a:off x="3559766" y="1300912"/>
          <a:ext cx="2954427" cy="429132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00680"/>
                <a:gridCol w="245079"/>
                <a:gridCol w="2108668"/>
              </a:tblGrid>
              <a:tr h="628650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quences of m6A related</a:t>
                      </a:r>
                      <a:r>
                        <a:rPr lang="en-US" sz="1000" b="1" i="0" u="none" strike="noStrike" kern="1200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gene</a:t>
                      </a:r>
                      <a:r>
                        <a:rPr lang="en-US" sz="10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primers used for qRT-PCR</a:t>
                      </a:r>
                      <a:endParaRPr lang="en-US" sz="1000" b="1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118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METTL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TGTCTCCAACCTTCCGTAGT</a:t>
                      </a:r>
                      <a:endParaRPr lang="zh-CN" altLang="en-US" dirty="0"/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36898">
                <a:tc>
                  <a:txBody>
                    <a:bodyPr/>
                    <a:lstStyle/>
                    <a:p>
                      <a:endParaRPr lang="zh-CN" altLang="en-US" b="1"/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CAGATCAGAGAGGTGGTGTAG</a:t>
                      </a:r>
                      <a:endParaRPr lang="zh-CN" altLang="en-US" dirty="0"/>
                    </a:p>
                  </a:txBody>
                  <a:tcPr marL="9525" marR="9525" marT="9525" marB="0" anchor="b"/>
                </a:tc>
              </a:tr>
              <a:tr h="8927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METTL1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TGCCGACAGCATTGGTG</a:t>
                      </a:r>
                      <a:endParaRPr lang="zh-CN" altLang="en-US" dirty="0"/>
                    </a:p>
                  </a:txBody>
                  <a:tcPr marL="9525" marR="9525" marT="9525" marB="0" anchor="b"/>
                </a:tc>
              </a:tr>
              <a:tr h="125468">
                <a:tc>
                  <a:txBody>
                    <a:bodyPr/>
                    <a:lstStyle/>
                    <a:p>
                      <a:endParaRPr lang="zh-CN" altLang="en-US" b="1"/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AGCAGAGGTATCATAGGAAGC</a:t>
                      </a:r>
                      <a:endParaRPr lang="zh-CN" altLang="en-US" dirty="0"/>
                    </a:p>
                  </a:txBody>
                  <a:tcPr marL="9525" marR="9525" marT="9525" marB="0" anchor="b"/>
                </a:tc>
              </a:tr>
              <a:tr h="18452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METTL1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CTGACGTGTACTCTCCTAAGG</a:t>
                      </a:r>
                      <a:endParaRPr lang="zh-CN" altLang="en-US" dirty="0"/>
                    </a:p>
                  </a:txBody>
                  <a:tcPr marL="9525" marR="9525" marT="9525" marB="0" anchor="b"/>
                </a:tc>
              </a:tr>
              <a:tr h="182880">
                <a:tc>
                  <a:txBody>
                    <a:bodyPr/>
                    <a:lstStyle/>
                    <a:p>
                      <a:endParaRPr lang="zh-CN" altLang="en-US" b="1"/>
                    </a:p>
                  </a:txBody>
                  <a:tcPr marL="9525" marR="9525" marT="9525" marB="0" anchor="b"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ACCAGCCATTCAAGGTTGCT</a:t>
                      </a:r>
                      <a:endParaRPr lang="zh-CN" altLang="en-US" dirty="0"/>
                    </a:p>
                  </a:txBody>
                  <a:tcPr marL="9525" marR="9525" marT="9525" marB="0" anchor="b"/>
                </a:tc>
              </a:tr>
              <a:tr h="17526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RBM15B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ACACGGAGGCTACCAGTACA</a:t>
                      </a:r>
                      <a:endParaRPr lang="zh-CN" altLang="en-US" dirty="0"/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endParaRPr lang="zh-CN" altLang="en-US" b="1"/>
                    </a:p>
                  </a:txBody>
                  <a:tcPr marL="9525" marR="9525" marT="9525" marB="0" anchor="b"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GTACAGCCCGTAGTAGTC</a:t>
                      </a:r>
                      <a:endParaRPr lang="zh-CN" altLang="en-US" dirty="0"/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marL="0" marR="0" indent="0" algn="l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FTO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TTGGCTCCCTTATCTGACC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endParaRPr lang="zh-CN" altLang="en-US" b="1"/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TGCAGTGTGAGAAAGGCTT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WTAP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TCCCAAGAAGGTTCGATTG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endParaRPr lang="zh-CN" altLang="en-US" b="1"/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AGACTCTCTTAGGCCAGTTAC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effectLst/>
                          <a:latin typeface="Arial" panose="020B0604020202020204" pitchFamily="34" charset="0"/>
                        </a:rPr>
                        <a:t>NSUN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AGCTGTTCGAGCACTACTAC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endParaRPr lang="zh-CN" altLang="en-US" b="1"/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CCCTGAGAGCGTCCATG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YTHDF3</a:t>
                      </a:r>
                      <a:endParaRPr lang="en-US" altLang="zh-CN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AGAGTAACAGCTATCCACC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TTGTCAGATATGGCATAGGCT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marL="0" marR="0" indent="0" algn="l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FMR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CCCCATTGAGATGTCGATGC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TGCTTGTTGAACCTGGTG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ALKBH5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GGCGAAGGCTACACTTACG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algn="l" fontAlgn="b"/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CACCAGCTTTTGGATCACCA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85428">
                <a:tc>
                  <a:txBody>
                    <a:bodyPr/>
                    <a:lstStyle/>
                    <a:p>
                      <a:pPr marL="0" marR="0" indent="0" algn="l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1" i="0" u="none" strike="noStrike" dirty="0" smtClean="0">
                          <a:effectLst/>
                          <a:latin typeface="Arial" panose="020B0604020202020204" pitchFamily="34" charset="0"/>
                        </a:rPr>
                        <a:t>YTHDF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CCCCACTTCCTACCAGATG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9715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015" b="0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AGAACTGTTATTTCCCCATGC</a:t>
                      </a:r>
                      <a:endParaRPr lang="en-US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矩形 6"/>
          <p:cNvSpPr/>
          <p:nvPr/>
        </p:nvSpPr>
        <p:spPr>
          <a:xfrm>
            <a:off x="353675" y="623172"/>
            <a:ext cx="683089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Table </a:t>
            </a:r>
            <a:r>
              <a:rPr lang="en-US" altLang="zh-CN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1</a:t>
            </a:r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</a:t>
            </a:r>
            <a:r>
              <a:rPr lang="en-US" altLang="zh-CN" sz="16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Oligonucleotide </a:t>
            </a:r>
            <a:r>
              <a:rPr lang="en-US" altLang="zh-CN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equences, Antibody and Inhibitor </a:t>
            </a:r>
          </a:p>
          <a:p>
            <a:r>
              <a:rPr lang="en-US" altLang="zh-CN" sz="16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16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             used </a:t>
            </a:r>
            <a:r>
              <a:rPr lang="en-US" altLang="zh-CN" sz="16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in this study </a:t>
            </a:r>
            <a:endParaRPr lang="zh-CN" altLang="en-US" sz="16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8002827"/>
              </p:ext>
            </p:extLst>
          </p:nvPr>
        </p:nvGraphicFramePr>
        <p:xfrm>
          <a:off x="698047" y="721895"/>
          <a:ext cx="5302704" cy="363039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88714"/>
                <a:gridCol w="3713990"/>
              </a:tblGrid>
              <a:tr h="421781">
                <a:tc>
                  <a:txBody>
                    <a:bodyPr/>
                    <a:lstStyle/>
                    <a:p>
                      <a:r>
                        <a:rPr lang="en-US" altLang="zh-C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zh-CN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ing</a:t>
                      </a:r>
                      <a:r>
                        <a:rPr lang="en-US" altLang="zh-CN" sz="11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or construct plasmid</a:t>
                      </a:r>
                      <a:endParaRPr lang="en-US" altLang="zh-CN" sz="11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0250">
                <a:tc>
                  <a:txBody>
                    <a:bodyPr/>
                    <a:lstStyle/>
                    <a:p>
                      <a:r>
                        <a:rPr lang="en-US" altLang="zh-C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KO.1-sh-P2RX6 1#</a:t>
                      </a:r>
                      <a:endParaRPr lang="zh-CN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CCGGCACACACAGCCACGGTGTAAATTGGATCCGTTTACACCGTGGCTGTGTGTGTTTTTG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60250">
                <a:tc>
                  <a:txBody>
                    <a:bodyPr/>
                    <a:lstStyle/>
                    <a:p>
                      <a:endParaRPr lang="zh-CN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altLang="zh-CN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AATTCAAAAACACACACAGCCACGGTGTAAACGGATCCAATTTACACCGTGGCTGTGTGTG</a:t>
                      </a:r>
                    </a:p>
                  </a:txBody>
                  <a:tcPr anchor="ctr"/>
                </a:tc>
              </a:tr>
              <a:tr h="360250">
                <a:tc>
                  <a:txBody>
                    <a:bodyPr/>
                    <a:lstStyle/>
                    <a:p>
                      <a:r>
                        <a:rPr lang="en-US" altLang="zh-C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KO.1-sh-P2RX6</a:t>
                      </a:r>
                      <a:r>
                        <a:rPr lang="en-US" altLang="zh-CN" sz="11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#</a:t>
                      </a:r>
                      <a:endParaRPr lang="zh-CN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altLang="zh-CN" sz="1000" kern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CCGGAGCAAGTTCAACTTCTCTAAGTTGGATCCGCTTAGAGAAGTTGAACTTGCTTTTTTG</a:t>
                      </a:r>
                      <a:endParaRPr lang="zh-CN" altLang="zh-CN" sz="1000" kern="1200" dirty="0" smtClean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60250">
                <a:tc>
                  <a:txBody>
                    <a:bodyPr/>
                    <a:lstStyle/>
                    <a:p>
                      <a:endParaRPr lang="zh-CN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kern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AATTCAAAAAAGCAAGTTCAACTTCTCTAAGCGGATCCAACTTAGAGAAGTTGAACTTGCT</a:t>
                      </a:r>
                      <a:endParaRPr lang="en-US" altLang="zh-CN" sz="1000" kern="1200" dirty="0" smtClean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60250">
                <a:tc>
                  <a:txBody>
                    <a:bodyPr/>
                    <a:lstStyle/>
                    <a:p>
                      <a:r>
                        <a:rPr lang="en-US" altLang="zh-C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KO.1-sh-MMP9</a:t>
                      </a:r>
                      <a:endParaRPr lang="zh-CN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kern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:CCGGCCACAACATCACCTATTGGATTTGGATCCGATCCAATAGGTGATGTTGTGGTTTTTG</a:t>
                      </a:r>
                      <a:endParaRPr lang="en-US" altLang="zh-CN" sz="1000" kern="1200" dirty="0" smtClean="0">
                        <a:solidFill>
                          <a:schemeClr val="dk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</a:tr>
              <a:tr h="360250">
                <a:tc>
                  <a:txBody>
                    <a:bodyPr/>
                    <a:lstStyle/>
                    <a:p>
                      <a:endParaRPr lang="zh-CN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kern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:AATTCAAAAACCACAACATCACCTATTGGATCGGATCCAAATCCAATAGGTGATGTTGTGG</a:t>
                      </a:r>
                    </a:p>
                  </a:txBody>
                  <a:tcPr anchor="ctr"/>
                </a:tc>
              </a:tr>
              <a:tr h="434934">
                <a:tc>
                  <a:txBody>
                    <a:bodyPr/>
                    <a:lstStyle/>
                    <a:p>
                      <a:r>
                        <a:rPr lang="en-US" altLang="zh-C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KO.1-sh-METTL14</a:t>
                      </a:r>
                      <a:endParaRPr lang="zh-CN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altLang="zh-CN" sz="10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:CCGGCCATGTACTTACAAGCCGATATTGGATCCGTATCGGCTTGTAAGTACATGGTTTTTG</a:t>
                      </a:r>
                      <a:endParaRPr lang="zh-CN" altLang="zh-CN" sz="1000" kern="12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noFill/>
                  </a:tcPr>
                </a:tc>
              </a:tr>
              <a:tr h="360250">
                <a:tc>
                  <a:txBody>
                    <a:bodyPr/>
                    <a:lstStyle/>
                    <a:p>
                      <a:endParaRPr lang="zh-CN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kern="12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:AATTCAAAAACCATGTACTTACAAGCCGATACGGATCCAATATCGGCTTGTAAGTACATGG</a:t>
                      </a:r>
                      <a:endParaRPr lang="zh-CN" altLang="zh-CN" sz="1000" kern="12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7685799"/>
              </p:ext>
            </p:extLst>
          </p:nvPr>
        </p:nvGraphicFramePr>
        <p:xfrm>
          <a:off x="647929" y="5004796"/>
          <a:ext cx="5401598" cy="2522531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035919"/>
                <a:gridCol w="1035919"/>
                <a:gridCol w="1035919"/>
                <a:gridCol w="1035919"/>
                <a:gridCol w="1257922"/>
              </a:tblGrid>
              <a:tr h="203580">
                <a:tc gridSpan="5"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/>
                </a:tc>
              </a:tr>
              <a:tr h="20358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ny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 No.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t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ed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0358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RX6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Tex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X16843</a:t>
                      </a:r>
                      <a:endParaRPr lang="en-US" altLang="zh-CN" sz="11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  <a:endParaRPr lang="en-US" altLang="zh-CN" sz="11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358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9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Tex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X2216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  <a:endParaRPr lang="en-US" altLang="zh-CN" sz="1100" b="0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358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13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Tex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X1006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358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ERK1/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b21436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35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K1/2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b1794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03580">
                <a:tc>
                  <a:txBody>
                    <a:bodyPr/>
                    <a:lstStyle/>
                    <a:p>
                      <a:pPr marL="0" marR="0" lvl="0" indent="0" algn="ctr" defTabSz="51435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6A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ynaptic Systems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02 003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  <a:endParaRPr lang="en-US" altLang="zh-CN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one</a:t>
                      </a:r>
                    </a:p>
                  </a:txBody>
                  <a:tcPr marL="9525" marR="9525" marT="9525" marB="0" anchor="ctr"/>
                </a:tc>
              </a:tr>
              <a:tr h="203580">
                <a:tc>
                  <a:txBody>
                    <a:bodyPr/>
                    <a:lstStyle/>
                    <a:p>
                      <a:pPr marL="0" marR="0" lvl="0" indent="0" algn="ctr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l-GR" altLang="zh-CN" sz="1100" b="1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altLang="zh-CN" sz="1100" b="1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ubulin</a:t>
                      </a:r>
                      <a:endParaRPr lang="en-US" altLang="zh-CN" sz="1100" b="1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c-13423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:500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21338">
                <a:tc>
                  <a:txBody>
                    <a:bodyPr/>
                    <a:lstStyle/>
                    <a:p>
                      <a:pPr marL="0" marR="0" lvl="0" indent="0" algn="ctr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l-GR" altLang="zh-CN" sz="1100" b="1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altLang="zh-CN" sz="1100" b="1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ctin</a:t>
                      </a:r>
                      <a:endParaRPr lang="zh-CN" altLang="en-US" sz="1100" b="1" i="0" u="none" strike="noStrike" kern="1200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c-8117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500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88101"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u="none" strike="noStrike" kern="12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lang="en-US" sz="1100" b="1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514350" rtl="0" eaLnBrk="1" fontAlgn="t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ct val="150000"/>
                        </a:lnSpc>
                      </a:pP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c-36506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50000"/>
                        </a:lnSpc>
                      </a:pPr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500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9761601"/>
              </p:ext>
            </p:extLst>
          </p:nvPr>
        </p:nvGraphicFramePr>
        <p:xfrm>
          <a:off x="610817" y="8117931"/>
          <a:ext cx="5506730" cy="107982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035919"/>
                <a:gridCol w="1035919"/>
                <a:gridCol w="958392"/>
                <a:gridCol w="1457325"/>
                <a:gridCol w="1019175"/>
              </a:tblGrid>
              <a:tr h="269955"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ll Molecular Inhibito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b"/>
                </a:tc>
              </a:tr>
              <a:tr h="26995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ny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 No.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nction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b="1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centration</a:t>
                      </a:r>
                      <a:endParaRPr lang="en-US" altLang="zh-CN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6995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apami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 Chemicals</a:t>
                      </a:r>
                      <a:endParaRPr lang="zh-CN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r>
                        <a:rPr lang="en-US" altLang="zh-CN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:52-53-9</a:t>
                      </a:r>
                      <a:endParaRPr lang="zh-CN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</a:t>
                      </a:r>
                      <a:r>
                        <a:rPr lang="en-US" altLang="zh-CN" sz="1100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+</a:t>
                      </a:r>
                      <a:r>
                        <a:rPr lang="en-US" altLang="zh-CN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channel block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u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  <a:tr h="26995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H77298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elleckche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S710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K1/2 inhibitor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51435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uM</a:t>
                      </a:r>
                      <a:endParaRPr lang="zh-CN" altLang="en-US" sz="11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7368454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7</TotalTime>
  <Words>355</Words>
  <Application>Microsoft Office PowerPoint</Application>
  <PresentationFormat>A4 纸张(210x297 毫米)</PresentationFormat>
  <Paragraphs>243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Arial Unicode MS</vt:lpstr>
      <vt:lpstr>宋体</vt:lpstr>
      <vt:lpstr>Arial</vt:lpstr>
      <vt:lpstr>Calibri</vt:lpstr>
      <vt:lpstr>Calibri Light</vt:lpstr>
      <vt:lpstr>1_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k gong</dc:creator>
  <cp:lastModifiedBy>Gong DK</cp:lastModifiedBy>
  <cp:revision>308</cp:revision>
  <cp:lastPrinted>2018-09-03T11:38:00Z</cp:lastPrinted>
  <dcterms:created xsi:type="dcterms:W3CDTF">2018-03-11T20:34:00Z</dcterms:created>
  <dcterms:modified xsi:type="dcterms:W3CDTF">2019-04-20T16:02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7849</vt:lpwstr>
  </property>
</Properties>
</file>